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chu\Documents\CIHI%20HCV%20data\Overall%20liver%20hospitalizations_Canada_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onthly</a:t>
            </a:r>
            <a:r>
              <a:rPr lang="en-US" baseline="0" dirty="0"/>
              <a:t> r</a:t>
            </a:r>
            <a:r>
              <a:rPr lang="en-US" dirty="0"/>
              <a:t>ate of total liver-related hospitalizations</a:t>
            </a:r>
            <a:r>
              <a:rPr lang="en-US" baseline="0" dirty="0"/>
              <a:t> with HCC per 1,000,000 of Canadian population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6"/>
          <c:order val="0"/>
          <c:tx>
            <c:strRef>
              <c:f>Sheet1!$H$1</c:f>
              <c:strCache>
                <c:ptCount val="1"/>
                <c:pt idx="0">
                  <c:v>HCC rate per 1M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cat>
            <c:numRef>
              <c:f>Sheet1!$A$2:$A$169</c:f>
              <c:numCache>
                <c:formatCode>[$-409]mmmm\ d\,\ yyyy;@</c:formatCode>
                <c:ptCount val="168"/>
                <c:pt idx="0">
                  <c:v>38808</c:v>
                </c:pt>
                <c:pt idx="1">
                  <c:v>38838</c:v>
                </c:pt>
                <c:pt idx="2">
                  <c:v>38869</c:v>
                </c:pt>
                <c:pt idx="3">
                  <c:v>38899</c:v>
                </c:pt>
                <c:pt idx="4">
                  <c:v>38930</c:v>
                </c:pt>
                <c:pt idx="5">
                  <c:v>38961</c:v>
                </c:pt>
                <c:pt idx="6">
                  <c:v>38991</c:v>
                </c:pt>
                <c:pt idx="7">
                  <c:v>39022</c:v>
                </c:pt>
                <c:pt idx="8">
                  <c:v>39052</c:v>
                </c:pt>
                <c:pt idx="9">
                  <c:v>39083</c:v>
                </c:pt>
                <c:pt idx="10">
                  <c:v>39114</c:v>
                </c:pt>
                <c:pt idx="11">
                  <c:v>39142</c:v>
                </c:pt>
                <c:pt idx="12">
                  <c:v>39173</c:v>
                </c:pt>
                <c:pt idx="13">
                  <c:v>39203</c:v>
                </c:pt>
                <c:pt idx="14">
                  <c:v>39234</c:v>
                </c:pt>
                <c:pt idx="15">
                  <c:v>39264</c:v>
                </c:pt>
                <c:pt idx="16">
                  <c:v>39295</c:v>
                </c:pt>
                <c:pt idx="17">
                  <c:v>39326</c:v>
                </c:pt>
                <c:pt idx="18">
                  <c:v>39356</c:v>
                </c:pt>
                <c:pt idx="19">
                  <c:v>39387</c:v>
                </c:pt>
                <c:pt idx="20">
                  <c:v>39417</c:v>
                </c:pt>
                <c:pt idx="21">
                  <c:v>39448</c:v>
                </c:pt>
                <c:pt idx="22">
                  <c:v>39479</c:v>
                </c:pt>
                <c:pt idx="23">
                  <c:v>39508</c:v>
                </c:pt>
                <c:pt idx="24">
                  <c:v>39539</c:v>
                </c:pt>
                <c:pt idx="25">
                  <c:v>39569</c:v>
                </c:pt>
                <c:pt idx="26">
                  <c:v>39600</c:v>
                </c:pt>
                <c:pt idx="27">
                  <c:v>39630</c:v>
                </c:pt>
                <c:pt idx="28">
                  <c:v>39661</c:v>
                </c:pt>
                <c:pt idx="29">
                  <c:v>39692</c:v>
                </c:pt>
                <c:pt idx="30">
                  <c:v>39722</c:v>
                </c:pt>
                <c:pt idx="31">
                  <c:v>39753</c:v>
                </c:pt>
                <c:pt idx="32">
                  <c:v>39783</c:v>
                </c:pt>
                <c:pt idx="33">
                  <c:v>39814</c:v>
                </c:pt>
                <c:pt idx="34">
                  <c:v>39845</c:v>
                </c:pt>
                <c:pt idx="35">
                  <c:v>39873</c:v>
                </c:pt>
                <c:pt idx="36">
                  <c:v>39904</c:v>
                </c:pt>
                <c:pt idx="37">
                  <c:v>39934</c:v>
                </c:pt>
                <c:pt idx="38">
                  <c:v>39965</c:v>
                </c:pt>
                <c:pt idx="39">
                  <c:v>39995</c:v>
                </c:pt>
                <c:pt idx="40">
                  <c:v>40026</c:v>
                </c:pt>
                <c:pt idx="41">
                  <c:v>40057</c:v>
                </c:pt>
                <c:pt idx="42">
                  <c:v>40087</c:v>
                </c:pt>
                <c:pt idx="43">
                  <c:v>40118</c:v>
                </c:pt>
                <c:pt idx="44">
                  <c:v>40148</c:v>
                </c:pt>
                <c:pt idx="45">
                  <c:v>40179</c:v>
                </c:pt>
                <c:pt idx="46">
                  <c:v>40210</c:v>
                </c:pt>
                <c:pt idx="47">
                  <c:v>40238</c:v>
                </c:pt>
                <c:pt idx="48">
                  <c:v>40269</c:v>
                </c:pt>
                <c:pt idx="49">
                  <c:v>40299</c:v>
                </c:pt>
                <c:pt idx="50">
                  <c:v>40330</c:v>
                </c:pt>
                <c:pt idx="51">
                  <c:v>40360</c:v>
                </c:pt>
                <c:pt idx="52">
                  <c:v>40391</c:v>
                </c:pt>
                <c:pt idx="53">
                  <c:v>40422</c:v>
                </c:pt>
                <c:pt idx="54">
                  <c:v>40452</c:v>
                </c:pt>
                <c:pt idx="55">
                  <c:v>40483</c:v>
                </c:pt>
                <c:pt idx="56">
                  <c:v>40513</c:v>
                </c:pt>
                <c:pt idx="57">
                  <c:v>40544</c:v>
                </c:pt>
                <c:pt idx="58">
                  <c:v>40575</c:v>
                </c:pt>
                <c:pt idx="59">
                  <c:v>40603</c:v>
                </c:pt>
                <c:pt idx="60">
                  <c:v>40634</c:v>
                </c:pt>
                <c:pt idx="61">
                  <c:v>40664</c:v>
                </c:pt>
                <c:pt idx="62">
                  <c:v>40695</c:v>
                </c:pt>
                <c:pt idx="63">
                  <c:v>40725</c:v>
                </c:pt>
                <c:pt idx="64">
                  <c:v>40756</c:v>
                </c:pt>
                <c:pt idx="65">
                  <c:v>40787</c:v>
                </c:pt>
                <c:pt idx="66">
                  <c:v>40817</c:v>
                </c:pt>
                <c:pt idx="67">
                  <c:v>40848</c:v>
                </c:pt>
                <c:pt idx="68">
                  <c:v>40878</c:v>
                </c:pt>
                <c:pt idx="69">
                  <c:v>40909</c:v>
                </c:pt>
                <c:pt idx="70">
                  <c:v>40940</c:v>
                </c:pt>
                <c:pt idx="71">
                  <c:v>40969</c:v>
                </c:pt>
                <c:pt idx="72">
                  <c:v>41000</c:v>
                </c:pt>
                <c:pt idx="73">
                  <c:v>41030</c:v>
                </c:pt>
                <c:pt idx="74">
                  <c:v>41061</c:v>
                </c:pt>
                <c:pt idx="75">
                  <c:v>41091</c:v>
                </c:pt>
                <c:pt idx="76">
                  <c:v>41122</c:v>
                </c:pt>
                <c:pt idx="77">
                  <c:v>41153</c:v>
                </c:pt>
                <c:pt idx="78">
                  <c:v>41183</c:v>
                </c:pt>
                <c:pt idx="79">
                  <c:v>41214</c:v>
                </c:pt>
                <c:pt idx="80">
                  <c:v>41244</c:v>
                </c:pt>
                <c:pt idx="81">
                  <c:v>41275</c:v>
                </c:pt>
                <c:pt idx="82">
                  <c:v>41306</c:v>
                </c:pt>
                <c:pt idx="83">
                  <c:v>41334</c:v>
                </c:pt>
                <c:pt idx="84">
                  <c:v>41365</c:v>
                </c:pt>
                <c:pt idx="85">
                  <c:v>41395</c:v>
                </c:pt>
                <c:pt idx="86">
                  <c:v>41426</c:v>
                </c:pt>
                <c:pt idx="87">
                  <c:v>41456</c:v>
                </c:pt>
                <c:pt idx="88">
                  <c:v>41487</c:v>
                </c:pt>
                <c:pt idx="89">
                  <c:v>41518</c:v>
                </c:pt>
                <c:pt idx="90">
                  <c:v>41548</c:v>
                </c:pt>
                <c:pt idx="91">
                  <c:v>41579</c:v>
                </c:pt>
                <c:pt idx="92">
                  <c:v>41609</c:v>
                </c:pt>
                <c:pt idx="93">
                  <c:v>41640</c:v>
                </c:pt>
                <c:pt idx="94">
                  <c:v>41671</c:v>
                </c:pt>
                <c:pt idx="95">
                  <c:v>41699</c:v>
                </c:pt>
                <c:pt idx="96">
                  <c:v>41730</c:v>
                </c:pt>
                <c:pt idx="97">
                  <c:v>41760</c:v>
                </c:pt>
                <c:pt idx="98">
                  <c:v>41791</c:v>
                </c:pt>
                <c:pt idx="99">
                  <c:v>41821</c:v>
                </c:pt>
                <c:pt idx="100">
                  <c:v>41852</c:v>
                </c:pt>
                <c:pt idx="101">
                  <c:v>41883</c:v>
                </c:pt>
                <c:pt idx="102">
                  <c:v>41913</c:v>
                </c:pt>
                <c:pt idx="103">
                  <c:v>41944</c:v>
                </c:pt>
                <c:pt idx="104">
                  <c:v>41974</c:v>
                </c:pt>
                <c:pt idx="105">
                  <c:v>42005</c:v>
                </c:pt>
                <c:pt idx="106">
                  <c:v>42036</c:v>
                </c:pt>
                <c:pt idx="107">
                  <c:v>42064</c:v>
                </c:pt>
                <c:pt idx="108">
                  <c:v>42095</c:v>
                </c:pt>
                <c:pt idx="109">
                  <c:v>42125</c:v>
                </c:pt>
                <c:pt idx="110">
                  <c:v>42156</c:v>
                </c:pt>
                <c:pt idx="111">
                  <c:v>42186</c:v>
                </c:pt>
                <c:pt idx="112">
                  <c:v>42217</c:v>
                </c:pt>
                <c:pt idx="113">
                  <c:v>42248</c:v>
                </c:pt>
                <c:pt idx="114">
                  <c:v>42278</c:v>
                </c:pt>
                <c:pt idx="115">
                  <c:v>42309</c:v>
                </c:pt>
                <c:pt idx="116">
                  <c:v>42339</c:v>
                </c:pt>
                <c:pt idx="117">
                  <c:v>42370</c:v>
                </c:pt>
                <c:pt idx="118">
                  <c:v>42401</c:v>
                </c:pt>
                <c:pt idx="119">
                  <c:v>42430</c:v>
                </c:pt>
                <c:pt idx="120">
                  <c:v>42461</c:v>
                </c:pt>
                <c:pt idx="121">
                  <c:v>42491</c:v>
                </c:pt>
                <c:pt idx="122">
                  <c:v>42522</c:v>
                </c:pt>
                <c:pt idx="123">
                  <c:v>42552</c:v>
                </c:pt>
                <c:pt idx="124">
                  <c:v>42583</c:v>
                </c:pt>
                <c:pt idx="125">
                  <c:v>42614</c:v>
                </c:pt>
                <c:pt idx="126">
                  <c:v>42644</c:v>
                </c:pt>
                <c:pt idx="127">
                  <c:v>42675</c:v>
                </c:pt>
                <c:pt idx="128">
                  <c:v>42705</c:v>
                </c:pt>
                <c:pt idx="129">
                  <c:v>42736</c:v>
                </c:pt>
                <c:pt idx="130">
                  <c:v>42767</c:v>
                </c:pt>
                <c:pt idx="131">
                  <c:v>42795</c:v>
                </c:pt>
                <c:pt idx="132">
                  <c:v>42826</c:v>
                </c:pt>
                <c:pt idx="133">
                  <c:v>42856</c:v>
                </c:pt>
                <c:pt idx="134">
                  <c:v>42887</c:v>
                </c:pt>
                <c:pt idx="135">
                  <c:v>42917</c:v>
                </c:pt>
                <c:pt idx="136">
                  <c:v>42948</c:v>
                </c:pt>
                <c:pt idx="137">
                  <c:v>42979</c:v>
                </c:pt>
                <c:pt idx="138">
                  <c:v>43009</c:v>
                </c:pt>
                <c:pt idx="139">
                  <c:v>43040</c:v>
                </c:pt>
                <c:pt idx="140">
                  <c:v>43070</c:v>
                </c:pt>
                <c:pt idx="141">
                  <c:v>43101</c:v>
                </c:pt>
                <c:pt idx="142">
                  <c:v>43132</c:v>
                </c:pt>
                <c:pt idx="143">
                  <c:v>43160</c:v>
                </c:pt>
                <c:pt idx="144">
                  <c:v>43191</c:v>
                </c:pt>
                <c:pt idx="145">
                  <c:v>43221</c:v>
                </c:pt>
                <c:pt idx="146">
                  <c:v>43252</c:v>
                </c:pt>
                <c:pt idx="147">
                  <c:v>43282</c:v>
                </c:pt>
                <c:pt idx="148">
                  <c:v>43313</c:v>
                </c:pt>
                <c:pt idx="149">
                  <c:v>43344</c:v>
                </c:pt>
                <c:pt idx="150">
                  <c:v>43374</c:v>
                </c:pt>
                <c:pt idx="151">
                  <c:v>43405</c:v>
                </c:pt>
                <c:pt idx="152">
                  <c:v>43435</c:v>
                </c:pt>
                <c:pt idx="153">
                  <c:v>43466</c:v>
                </c:pt>
                <c:pt idx="154">
                  <c:v>43497</c:v>
                </c:pt>
                <c:pt idx="155">
                  <c:v>43525</c:v>
                </c:pt>
                <c:pt idx="156">
                  <c:v>43556</c:v>
                </c:pt>
                <c:pt idx="157">
                  <c:v>43586</c:v>
                </c:pt>
                <c:pt idx="158">
                  <c:v>43617</c:v>
                </c:pt>
                <c:pt idx="159">
                  <c:v>43647</c:v>
                </c:pt>
                <c:pt idx="160">
                  <c:v>43678</c:v>
                </c:pt>
                <c:pt idx="161">
                  <c:v>43709</c:v>
                </c:pt>
                <c:pt idx="162">
                  <c:v>43739</c:v>
                </c:pt>
                <c:pt idx="163">
                  <c:v>43770</c:v>
                </c:pt>
                <c:pt idx="164">
                  <c:v>43800</c:v>
                </c:pt>
                <c:pt idx="165">
                  <c:v>43831</c:v>
                </c:pt>
                <c:pt idx="166">
                  <c:v>43862</c:v>
                </c:pt>
                <c:pt idx="167">
                  <c:v>43891</c:v>
                </c:pt>
              </c:numCache>
            </c:numRef>
          </c:cat>
          <c:val>
            <c:numRef>
              <c:f>Sheet1!$H$2:$H$169</c:f>
              <c:numCache>
                <c:formatCode>General</c:formatCode>
                <c:ptCount val="168"/>
                <c:pt idx="0">
                  <c:v>4.4656189380185332</c:v>
                </c:pt>
                <c:pt idx="1">
                  <c:v>4.7686546179343656</c:v>
                </c:pt>
                <c:pt idx="2">
                  <c:v>4.763726783734211</c:v>
                </c:pt>
                <c:pt idx="3">
                  <c:v>5.2500410332154432</c:v>
                </c:pt>
                <c:pt idx="4">
                  <c:v>4.6308099542173382</c:v>
                </c:pt>
                <c:pt idx="5">
                  <c:v>4.5643637474010434</c:v>
                </c:pt>
                <c:pt idx="6">
                  <c:v>4.9264532547516096</c:v>
                </c:pt>
                <c:pt idx="7">
                  <c:v>3.8540311202817112</c:v>
                </c:pt>
                <c:pt idx="8">
                  <c:v>4.1277623367757919</c:v>
                </c:pt>
                <c:pt idx="9">
                  <c:v>4.6152387051889745</c:v>
                </c:pt>
                <c:pt idx="10">
                  <c:v>3.8484478782101856</c:v>
                </c:pt>
                <c:pt idx="11">
                  <c:v>5.4634396234829374</c:v>
                </c:pt>
                <c:pt idx="12">
                  <c:v>3.6600972597644841</c:v>
                </c:pt>
                <c:pt idx="13">
                  <c:v>4.7226795350238637</c:v>
                </c:pt>
                <c:pt idx="14">
                  <c:v>5.1438625744977404</c:v>
                </c:pt>
                <c:pt idx="15">
                  <c:v>5.624976720957827</c:v>
                </c:pt>
                <c:pt idx="16">
                  <c:v>5.4059423332946075</c:v>
                </c:pt>
                <c:pt idx="17">
                  <c:v>4.9143874770648015</c:v>
                </c:pt>
                <c:pt idx="18">
                  <c:v>5.423891021848342</c:v>
                </c:pt>
                <c:pt idx="19">
                  <c:v>5.209233034423975</c:v>
                </c:pt>
                <c:pt idx="20">
                  <c:v>4.3288137020252915</c:v>
                </c:pt>
                <c:pt idx="21">
                  <c:v>4.3266973595920906</c:v>
                </c:pt>
                <c:pt idx="22">
                  <c:v>5.1698728511594814</c:v>
                </c:pt>
                <c:pt idx="23">
                  <c:v>4.6523031271945818</c:v>
                </c:pt>
                <c:pt idx="24">
                  <c:v>4.9807531623254624</c:v>
                </c:pt>
                <c:pt idx="25">
                  <c:v>4.2813141801406953</c:v>
                </c:pt>
                <c:pt idx="26">
                  <c:v>4.8182246456286117</c:v>
                </c:pt>
                <c:pt idx="27">
                  <c:v>4.8425249972042694</c:v>
                </c:pt>
                <c:pt idx="28">
                  <c:v>5.2870500697860567</c:v>
                </c:pt>
                <c:pt idx="29">
                  <c:v>4.9804007230421758</c:v>
                </c:pt>
                <c:pt idx="30">
                  <c:v>5.064062184526156</c:v>
                </c:pt>
                <c:pt idx="31">
                  <c:v>4.7618151064860648</c:v>
                </c:pt>
                <c:pt idx="32">
                  <c:v>5.3877956729974397</c:v>
                </c:pt>
                <c:pt idx="33">
                  <c:v>5.3549445733320766</c:v>
                </c:pt>
                <c:pt idx="34">
                  <c:v>4.2146009019544843</c:v>
                </c:pt>
                <c:pt idx="35">
                  <c:v>4.9577101352319977</c:v>
                </c:pt>
                <c:pt idx="36">
                  <c:v>4.5656275387910492</c:v>
                </c:pt>
                <c:pt idx="37">
                  <c:v>6.2592245943413927</c:v>
                </c:pt>
                <c:pt idx="38">
                  <c:v>4.8229086972276658</c:v>
                </c:pt>
                <c:pt idx="39">
                  <c:v>5.6796394886005031</c:v>
                </c:pt>
                <c:pt idx="40">
                  <c:v>5.0190631840360682</c:v>
                </c:pt>
                <c:pt idx="41">
                  <c:v>6.0804969405262828</c:v>
                </c:pt>
                <c:pt idx="42">
                  <c:v>6.0431772573199982</c:v>
                </c:pt>
                <c:pt idx="43">
                  <c:v>5.8625161210557462</c:v>
                </c:pt>
                <c:pt idx="44">
                  <c:v>5.7412226742585615</c:v>
                </c:pt>
                <c:pt idx="45">
                  <c:v>5.9750004207642622</c:v>
                </c:pt>
                <c:pt idx="46">
                  <c:v>5.290416580800021</c:v>
                </c:pt>
                <c:pt idx="47">
                  <c:v>6.0835153851562689</c:v>
                </c:pt>
                <c:pt idx="48">
                  <c:v>6.8163236255901429</c:v>
                </c:pt>
                <c:pt idx="49">
                  <c:v>5.5706551093356014</c:v>
                </c:pt>
                <c:pt idx="50">
                  <c:v>5.2404825035892895</c:v>
                </c:pt>
                <c:pt idx="51">
                  <c:v>6.4402504004644747</c:v>
                </c:pt>
                <c:pt idx="52">
                  <c:v>6.3147716283400337</c:v>
                </c:pt>
                <c:pt idx="53">
                  <c:v>5.720250140182797</c:v>
                </c:pt>
                <c:pt idx="54">
                  <c:v>6.3577292687266551</c:v>
                </c:pt>
                <c:pt idx="55">
                  <c:v>6.6484775645367282</c:v>
                </c:pt>
                <c:pt idx="56">
                  <c:v>6.412015566734194</c:v>
                </c:pt>
                <c:pt idx="57">
                  <c:v>6.3805938161099398</c:v>
                </c:pt>
                <c:pt idx="58">
                  <c:v>5.8793375080594696</c:v>
                </c:pt>
                <c:pt idx="59">
                  <c:v>6.8987790768800226</c:v>
                </c:pt>
                <c:pt idx="60">
                  <c:v>6.1349015777739879</c:v>
                </c:pt>
                <c:pt idx="61">
                  <c:v>6.0116682394928782</c:v>
                </c:pt>
                <c:pt idx="62">
                  <c:v>6.4134311084875213</c:v>
                </c:pt>
                <c:pt idx="63">
                  <c:v>6.8143441828564608</c:v>
                </c:pt>
                <c:pt idx="64">
                  <c:v>5.9338748763364002</c:v>
                </c:pt>
                <c:pt idx="65">
                  <c:v>6.8567892925308147</c:v>
                </c:pt>
                <c:pt idx="66">
                  <c:v>6.8779387589493739</c:v>
                </c:pt>
                <c:pt idx="67">
                  <c:v>7.9762280945222273</c:v>
                </c:pt>
                <c:pt idx="68">
                  <c:v>7.1310754081076766</c:v>
                </c:pt>
                <c:pt idx="69">
                  <c:v>6.6055648059215528</c:v>
                </c:pt>
                <c:pt idx="70">
                  <c:v>6.9480978920986072</c:v>
                </c:pt>
                <c:pt idx="71">
                  <c:v>7.6951330983199835</c:v>
                </c:pt>
                <c:pt idx="72">
                  <c:v>6.0706310990510479</c:v>
                </c:pt>
                <c:pt idx="73">
                  <c:v>6.6698890026523632</c:v>
                </c:pt>
                <c:pt idx="74">
                  <c:v>6.2583382623755544</c:v>
                </c:pt>
                <c:pt idx="75">
                  <c:v>7.2304659456288549</c:v>
                </c:pt>
                <c:pt idx="76">
                  <c:v>7.7974801996753405</c:v>
                </c:pt>
                <c:pt idx="77">
                  <c:v>7.7309041446632074</c:v>
                </c:pt>
                <c:pt idx="78">
                  <c:v>6.9468350104868506</c:v>
                </c:pt>
                <c:pt idx="79">
                  <c:v>7.4314857897701536</c:v>
                </c:pt>
                <c:pt idx="80">
                  <c:v>7.4854989251378035</c:v>
                </c:pt>
                <c:pt idx="81">
                  <c:v>6.7367829121014093</c:v>
                </c:pt>
                <c:pt idx="82">
                  <c:v>7.3048841104485485</c:v>
                </c:pt>
                <c:pt idx="83">
                  <c:v>7.7862929011976378</c:v>
                </c:pt>
                <c:pt idx="84">
                  <c:v>7.8093229929124526</c:v>
                </c:pt>
                <c:pt idx="85">
                  <c:v>8.085761568167646</c:v>
                </c:pt>
                <c:pt idx="86">
                  <c:v>7.2771117693213778</c:v>
                </c:pt>
                <c:pt idx="87">
                  <c:v>8.237618759241311</c:v>
                </c:pt>
                <c:pt idx="88">
                  <c:v>8.6830454399236032</c:v>
                </c:pt>
                <c:pt idx="89">
                  <c:v>7.8762780967264963</c:v>
                </c:pt>
                <c:pt idx="90">
                  <c:v>8.4914556928053742</c:v>
                </c:pt>
                <c:pt idx="91">
                  <c:v>8.7439247111743974</c:v>
                </c:pt>
                <c:pt idx="92">
                  <c:v>7.4353561058803797</c:v>
                </c:pt>
                <c:pt idx="93">
                  <c:v>7.773129251054173</c:v>
                </c:pt>
                <c:pt idx="94">
                  <c:v>7.5976057751858423</c:v>
                </c:pt>
                <c:pt idx="95">
                  <c:v>8.3572005380148511</c:v>
                </c:pt>
                <c:pt idx="96">
                  <c:v>6.8226471004471723</c:v>
                </c:pt>
                <c:pt idx="97">
                  <c:v>8.4555235830349993</c:v>
                </c:pt>
                <c:pt idx="98">
                  <c:v>7.2317471666687858</c:v>
                </c:pt>
                <c:pt idx="99">
                  <c:v>8.1834365269382499</c:v>
                </c:pt>
                <c:pt idx="100">
                  <c:v>7.638542514600867</c:v>
                </c:pt>
                <c:pt idx="101">
                  <c:v>7.9958309812342057</c:v>
                </c:pt>
                <c:pt idx="102">
                  <c:v>8.4085493067347965</c:v>
                </c:pt>
                <c:pt idx="103">
                  <c:v>7.085732043426427</c:v>
                </c:pt>
                <c:pt idx="104">
                  <c:v>7.3657976271842012</c:v>
                </c:pt>
                <c:pt idx="105">
                  <c:v>7.8706543411844896</c:v>
                </c:pt>
                <c:pt idx="106">
                  <c:v>7.1092947284579591</c:v>
                </c:pt>
                <c:pt idx="107">
                  <c:v>8.5675979121241426</c:v>
                </c:pt>
                <c:pt idx="108">
                  <c:v>8.8735951042017014</c:v>
                </c:pt>
                <c:pt idx="109">
                  <c:v>8.5854209638584642</c:v>
                </c:pt>
                <c:pt idx="110">
                  <c:v>8.6061023133623529</c:v>
                </c:pt>
                <c:pt idx="111">
                  <c:v>9.410998118136483</c:v>
                </c:pt>
                <c:pt idx="112">
                  <c:v>8.7290055060813465</c:v>
                </c:pt>
                <c:pt idx="113">
                  <c:v>8.2441616244691023</c:v>
                </c:pt>
                <c:pt idx="114">
                  <c:v>9.2399011648807612</c:v>
                </c:pt>
                <c:pt idx="115">
                  <c:v>9.0125346219912323</c:v>
                </c:pt>
                <c:pt idx="116">
                  <c:v>9.1200528617229129</c:v>
                </c:pt>
                <c:pt idx="117">
                  <c:v>9.1159644344689852</c:v>
                </c:pt>
                <c:pt idx="118">
                  <c:v>7.659272837920736</c:v>
                </c:pt>
                <c:pt idx="119">
                  <c:v>8.0974482352766373</c:v>
                </c:pt>
                <c:pt idx="120">
                  <c:v>8.7850246910625138</c:v>
                </c:pt>
                <c:pt idx="121">
                  <c:v>7.8574666289273818</c:v>
                </c:pt>
                <c:pt idx="122">
                  <c:v>9.2338171369792974</c:v>
                </c:pt>
                <c:pt idx="123">
                  <c:v>8.7234692644622722</c:v>
                </c:pt>
                <c:pt idx="124">
                  <c:v>8.5178797116826779</c:v>
                </c:pt>
                <c:pt idx="125">
                  <c:v>8.8099693207777854</c:v>
                </c:pt>
                <c:pt idx="126">
                  <c:v>8.9909391742004399</c:v>
                </c:pt>
                <c:pt idx="127">
                  <c:v>9.206888910367546</c:v>
                </c:pt>
                <c:pt idx="128">
                  <c:v>9.4501705273628644</c:v>
                </c:pt>
                <c:pt idx="129">
                  <c:v>8.2337166068749212</c:v>
                </c:pt>
                <c:pt idx="130">
                  <c:v>8.5850915244591963</c:v>
                </c:pt>
                <c:pt idx="131">
                  <c:v>8.4410131507043893</c:v>
                </c:pt>
                <c:pt idx="132">
                  <c:v>7.5553574861353008</c:v>
                </c:pt>
                <c:pt idx="133">
                  <c:v>8.2311104109992801</c:v>
                </c:pt>
                <c:pt idx="134">
                  <c:v>8.0556416503525465</c:v>
                </c:pt>
                <c:pt idx="135">
                  <c:v>8.1269142713977818</c:v>
                </c:pt>
                <c:pt idx="136">
                  <c:v>8.9607942032039478</c:v>
                </c:pt>
                <c:pt idx="137">
                  <c:v>9.1373868575573756</c:v>
                </c:pt>
                <c:pt idx="138">
                  <c:v>8.0879659155143067</c:v>
                </c:pt>
                <c:pt idx="139">
                  <c:v>7.5380402985629988</c:v>
                </c:pt>
                <c:pt idx="140">
                  <c:v>7.1248547121110439</c:v>
                </c:pt>
                <c:pt idx="141">
                  <c:v>7.1742234066212864</c:v>
                </c:pt>
                <c:pt idx="142">
                  <c:v>7.2220301023445828</c:v>
                </c:pt>
                <c:pt idx="143">
                  <c:v>7.9478986759560328</c:v>
                </c:pt>
                <c:pt idx="144">
                  <c:v>7.3715871550202232</c:v>
                </c:pt>
                <c:pt idx="145">
                  <c:v>7.8205374457345362</c:v>
                </c:pt>
                <c:pt idx="146">
                  <c:v>8.0789995377677428</c:v>
                </c:pt>
                <c:pt idx="147">
                  <c:v>7.958972924491416</c:v>
                </c:pt>
                <c:pt idx="148">
                  <c:v>8.6190988834469149</c:v>
                </c:pt>
                <c:pt idx="149">
                  <c:v>8.0132044702494731</c:v>
                </c:pt>
                <c:pt idx="150">
                  <c:v>7.9999173162908246</c:v>
                </c:pt>
                <c:pt idx="151">
                  <c:v>7.7799434934655851</c:v>
                </c:pt>
                <c:pt idx="152">
                  <c:v>8.5522134750444927</c:v>
                </c:pt>
                <c:pt idx="153">
                  <c:v>8.9751611744708377</c:v>
                </c:pt>
                <c:pt idx="154">
                  <c:v>7.1471007897180536</c:v>
                </c:pt>
                <c:pt idx="155">
                  <c:v>8.2374138935057655</c:v>
                </c:pt>
                <c:pt idx="156">
                  <c:v>7.2415464031078685</c:v>
                </c:pt>
                <c:pt idx="157">
                  <c:v>8.3239124608275876</c:v>
                </c:pt>
                <c:pt idx="158">
                  <c:v>7.7247224307453335</c:v>
                </c:pt>
                <c:pt idx="159">
                  <c:v>8.4305752763938848</c:v>
                </c:pt>
                <c:pt idx="160">
                  <c:v>8.4946356994958201</c:v>
                </c:pt>
                <c:pt idx="161">
                  <c:v>8.3729823784226625</c:v>
                </c:pt>
                <c:pt idx="162">
                  <c:v>8.0137449213883372</c:v>
                </c:pt>
                <c:pt idx="163">
                  <c:v>7.821784722164173</c:v>
                </c:pt>
                <c:pt idx="164">
                  <c:v>8.7126381833216531</c:v>
                </c:pt>
                <c:pt idx="165">
                  <c:v>7.6235192797615534</c:v>
                </c:pt>
                <c:pt idx="166">
                  <c:v>7.4074605200807024</c:v>
                </c:pt>
                <c:pt idx="167">
                  <c:v>8.14004995461724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E78-4666-9908-402D2974CB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89235663"/>
        <c:axId val="289240655"/>
      </c:lineChart>
      <c:dateAx>
        <c:axId val="28923566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Month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[$-409]mmmm\ d\,\ yyyy;@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9240655"/>
        <c:crosses val="autoZero"/>
        <c:auto val="1"/>
        <c:lblOffset val="100"/>
        <c:baseTimeUnit val="months"/>
      </c:dateAx>
      <c:valAx>
        <c:axId val="28924065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ate per 1,000,00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92356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06A055-8862-CCF1-DA6F-B57261727B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92C0A8D-C0BA-232E-F046-1C79A2806A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F65D37-8C67-3064-7986-F73FC65FDE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F3B98D-F51E-EA93-22FA-7BBE97FB7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43BE67-E697-EC75-067A-16A874B4B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352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C45A06-A577-62CF-A8B4-5E11473AE8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6A2AA8-05C7-5907-6CE5-0693F109C0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C8B3CF-C272-3CD2-6165-95782E6D2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0F5147-17B5-1ECC-0381-120CAE52D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78AC21-63AE-1E0E-9EC3-B5E76E4A4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075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2C8AC3-01B1-F84F-444B-54E12019BD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453EEE-0A75-F7D8-F3E6-5A02870CAE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493FC8-3B0D-01E9-91D7-02E35F9D10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56BC11-97E6-C8E6-600E-EE120515F9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46633D-0A07-9B25-1BA4-4D71FA3201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433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0839F7-63E0-E391-6EEC-BEEA7A7F95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FE4210-1CE4-A05F-5CF2-70566EC59A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0B28B2-EE60-38D2-4CCC-CEED1B4A18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FEF63C-DB35-08C7-E947-BB3527CEC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E4B331-78D9-37E8-EC28-F47E37614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194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2B1947-7BFC-5AC1-1B3E-E29957F99F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2B1837-8315-ADFA-EE89-65C02A4E89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6D5CD3-CB80-CF9B-3320-BDBEC62F1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A0FB7D-2903-BFFC-EA2A-52904D01B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139943-C4D9-F369-3D34-4806DDFEDE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612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485CA6-905A-EF3B-2D72-6F9E599429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90AE0A-1291-1322-A3B2-581F62B4B0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0A3EAA-527B-D622-3ED0-2EDA70048E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99290A-3465-D953-ECD1-158D14EA61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ED4B68-A99A-0D78-0077-749C6B833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EBD9CA-CCCE-A501-2D9D-1D625EA7A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0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410DEE-ADEE-762A-BE4C-B13028FF0A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A9EA24-4700-781F-283C-EEE038981A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9C8752-6E66-AFC9-2636-95356C9A35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DB2C63-F407-6D5D-D06C-8C99319855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D1BA4D6-0011-5F27-8AA3-68C652F799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18B0CC-2238-277F-D6ED-992AC5F34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1BE9DA-44F0-71B1-6677-C9333DEA5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DADEA73-4471-76E5-3855-868855A56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031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189B42-9765-2C31-F6CC-DAAD1E7479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963ADE-CBEC-B6C5-F365-493139D43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C0BCFAA-2680-1261-92D6-699600026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947D4C-EDED-A84D-796D-CEDD9BFA7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783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C729DE-8729-7E6C-2760-F8235152D1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E188CD-D3FD-A9BC-D3BD-7C4D9C60E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7AAD36B-124D-AFBE-C534-CD41F0BD5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694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9CB38-ACC3-26EC-1C82-C560FB3A3D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E9DF6D-B456-ED59-2E0E-520A3E4149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CC3925-2DE7-D3FF-9BE4-196E200033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315828-1311-C20C-1B84-BBFC50E77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42D9EC-E6BA-30BF-10BB-932FE9DDD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C083C2-E162-9530-7FC3-EDEA07704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69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41B047-1C49-A636-2F57-0830E860C0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BB9615D-F525-5A3A-8735-FFB51A5614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3446CA-7908-9D91-8FD6-3A2BEB597E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22D488-3E22-816E-8E84-858AC3830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E3E7D4-4A42-3A42-7BEF-D143AB8D4B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347B06-50F7-341B-206C-DBAE9F9A92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948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6B63CD-20F0-7610-3ECC-A19DAF0D8C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D73D4C-BC92-4E97-D367-44E1F54221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C3915A-4C15-AE71-9B98-5ACE9CA2FC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BDFDF1-C21B-48B0-AD65-B53170247678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14B74F-FEE9-CFAC-2FAE-CDA0A8A219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D2F6BF-7E25-964C-BC42-6EA7727A52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23C54-0330-4097-BD83-595172559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645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4DC6225-1EC6-4D12-9DBD-DE250ADB11AC}"/>
              </a:ext>
            </a:extLst>
          </p:cNvPr>
          <p:cNvGraphicFramePr>
            <a:graphicFrameLocks/>
          </p:cNvGraphicFramePr>
          <p:nvPr/>
        </p:nvGraphicFramePr>
        <p:xfrm>
          <a:off x="1445086" y="1085388"/>
          <a:ext cx="8934590" cy="4730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D231EB79-7F2C-4A8D-9D68-5E0724A65397}"/>
              </a:ext>
            </a:extLst>
          </p:cNvPr>
          <p:cNvCxnSpPr>
            <a:cxnSpLocks/>
          </p:cNvCxnSpPr>
          <p:nvPr/>
        </p:nvCxnSpPr>
        <p:spPr>
          <a:xfrm>
            <a:off x="6987745" y="1466335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13D0DBBA-6AC3-431F-AF63-40007C1373E9}"/>
              </a:ext>
            </a:extLst>
          </p:cNvPr>
          <p:cNvCxnSpPr>
            <a:cxnSpLocks/>
          </p:cNvCxnSpPr>
          <p:nvPr/>
        </p:nvCxnSpPr>
        <p:spPr>
          <a:xfrm>
            <a:off x="8305799" y="1466335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F3F99FC5-9302-1A37-2CBE-88D18500EDCB}"/>
              </a:ext>
            </a:extLst>
          </p:cNvPr>
          <p:cNvSpPr txBox="1"/>
          <p:nvPr/>
        </p:nvSpPr>
        <p:spPr>
          <a:xfrm>
            <a:off x="354227" y="350108"/>
            <a:ext cx="1989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8 Figure</a:t>
            </a:r>
          </a:p>
        </p:txBody>
      </p:sp>
    </p:spTree>
    <p:extLst>
      <p:ext uri="{BB962C8B-B14F-4D97-AF65-F5344CB8AC3E}">
        <p14:creationId xmlns:p14="http://schemas.microsoft.com/office/powerpoint/2010/main" val="54486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omen's College Hospit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, Cherry</dc:creator>
  <cp:lastModifiedBy>Chu, Cherry</cp:lastModifiedBy>
  <cp:revision>1</cp:revision>
  <dcterms:created xsi:type="dcterms:W3CDTF">2023-07-26T15:48:28Z</dcterms:created>
  <dcterms:modified xsi:type="dcterms:W3CDTF">2023-07-26T15:48:35Z</dcterms:modified>
</cp:coreProperties>
</file>